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9" r:id="rId2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785" autoAdjust="0"/>
    <p:restoredTop sz="99212" autoAdjust="0"/>
  </p:normalViewPr>
  <p:slideViewPr>
    <p:cSldViewPr snapToGrid="0">
      <p:cViewPr>
        <p:scale>
          <a:sx n="100" d="100"/>
          <a:sy n="100" d="100"/>
        </p:scale>
        <p:origin x="-2250" y="151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A72A18-1E15-4642-B432-445194E93E03}" type="datetimeFigureOut">
              <a:rPr lang="de-DE" smtClean="0"/>
              <a:t>13.1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C27A9F-94A1-45EC-B36A-87FFE7AA336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067346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A72A18-1E15-4642-B432-445194E93E03}" type="datetimeFigureOut">
              <a:rPr lang="de-DE" smtClean="0"/>
              <a:t>13.1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C27A9F-94A1-45EC-B36A-87FFE7AA336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586794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A72A18-1E15-4642-B432-445194E93E03}" type="datetimeFigureOut">
              <a:rPr lang="de-DE" smtClean="0"/>
              <a:t>13.1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C27A9F-94A1-45EC-B36A-87FFE7AA336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323509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A72A18-1E15-4642-B432-445194E93E03}" type="datetimeFigureOut">
              <a:rPr lang="de-DE" smtClean="0"/>
              <a:t>13.1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C27A9F-94A1-45EC-B36A-87FFE7AA336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876168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A72A18-1E15-4642-B432-445194E93E03}" type="datetimeFigureOut">
              <a:rPr lang="de-DE" smtClean="0"/>
              <a:t>13.1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C27A9F-94A1-45EC-B36A-87FFE7AA336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029644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A72A18-1E15-4642-B432-445194E93E03}" type="datetimeFigureOut">
              <a:rPr lang="de-DE" smtClean="0"/>
              <a:t>13.12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C27A9F-94A1-45EC-B36A-87FFE7AA336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209632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A72A18-1E15-4642-B432-445194E93E03}" type="datetimeFigureOut">
              <a:rPr lang="de-DE" smtClean="0"/>
              <a:t>13.12.2023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C27A9F-94A1-45EC-B36A-87FFE7AA336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531738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A72A18-1E15-4642-B432-445194E93E03}" type="datetimeFigureOut">
              <a:rPr lang="de-DE" smtClean="0"/>
              <a:t>13.12.2023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C27A9F-94A1-45EC-B36A-87FFE7AA336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535614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A72A18-1E15-4642-B432-445194E93E03}" type="datetimeFigureOut">
              <a:rPr lang="de-DE" smtClean="0"/>
              <a:t>13.12.2023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C27A9F-94A1-45EC-B36A-87FFE7AA336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586313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A72A18-1E15-4642-B432-445194E93E03}" type="datetimeFigureOut">
              <a:rPr lang="de-DE" smtClean="0"/>
              <a:t>13.12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C27A9F-94A1-45EC-B36A-87FFE7AA336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08917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A72A18-1E15-4642-B432-445194E93E03}" type="datetimeFigureOut">
              <a:rPr lang="de-DE" smtClean="0"/>
              <a:t>13.12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C27A9F-94A1-45EC-B36A-87FFE7AA336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303304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A72A18-1E15-4642-B432-445194E93E03}" type="datetimeFigureOut">
              <a:rPr lang="de-DE" smtClean="0"/>
              <a:t>13.1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C27A9F-94A1-45EC-B36A-87FFE7AA336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860726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5" name="Gruppieren 144"/>
          <p:cNvGrpSpPr/>
          <p:nvPr/>
        </p:nvGrpSpPr>
        <p:grpSpPr>
          <a:xfrm>
            <a:off x="-9" y="72671"/>
            <a:ext cx="6858009" cy="9831960"/>
            <a:chOff x="-9" y="72671"/>
            <a:chExt cx="6858009" cy="9831960"/>
          </a:xfrm>
        </p:grpSpPr>
        <p:grpSp>
          <p:nvGrpSpPr>
            <p:cNvPr id="144" name="Gruppieren 143"/>
            <p:cNvGrpSpPr/>
            <p:nvPr/>
          </p:nvGrpSpPr>
          <p:grpSpPr>
            <a:xfrm>
              <a:off x="-9" y="377364"/>
              <a:ext cx="6696084" cy="8749802"/>
              <a:chOff x="-9" y="319308"/>
              <a:chExt cx="6696084" cy="8749802"/>
            </a:xfrm>
          </p:grpSpPr>
          <p:pic>
            <p:nvPicPr>
              <p:cNvPr id="2" name="Grafik 1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49696"/>
              <a:stretch/>
            </p:blipFill>
            <p:spPr>
              <a:xfrm>
                <a:off x="-9" y="319308"/>
                <a:ext cx="6696084" cy="3243263"/>
              </a:xfrm>
              <a:prstGeom prst="rect">
                <a:avLst/>
              </a:prstGeom>
            </p:spPr>
          </p:pic>
          <p:grpSp>
            <p:nvGrpSpPr>
              <p:cNvPr id="3" name="Gruppieren 2"/>
              <p:cNvGrpSpPr/>
              <p:nvPr/>
            </p:nvGrpSpPr>
            <p:grpSpPr>
              <a:xfrm>
                <a:off x="147386" y="3578574"/>
                <a:ext cx="6508017" cy="561051"/>
                <a:chOff x="147386" y="3144966"/>
                <a:chExt cx="6508017" cy="561051"/>
              </a:xfrm>
            </p:grpSpPr>
            <p:sp>
              <p:nvSpPr>
                <p:cNvPr id="7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27321" y="3265031"/>
                  <a:ext cx="347851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01-NCR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204924" y="3338769"/>
                  <a:ext cx="495328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02-SPW (1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590505" y="3328350"/>
                  <a:ext cx="474489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03-EBD (1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949613" y="3346784"/>
                  <a:ext cx="511358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04-WW3 (1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1469421" y="3328350"/>
                  <a:ext cx="474489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05-BRE (1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1828531" y="3346784"/>
                  <a:ext cx="511358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06-WW6 (1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2206075" y="3346784"/>
                  <a:ext cx="511358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07-WW5 (1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2584423" y="3345983"/>
                  <a:ext cx="509755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08-SA18 (1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2989263" y="3313923"/>
                  <a:ext cx="445635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09-CHI (1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3579151" y="3353998"/>
                  <a:ext cx="525785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10-GNL1 (1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3979961" y="3328350"/>
                  <a:ext cx="474489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11-SAH (1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4354301" y="3331556"/>
                  <a:ext cx="480901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12-VOE (1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4711855" y="3346785"/>
                  <a:ext cx="511358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13-WW7 (1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5104629" y="3331556"/>
                  <a:ext cx="480901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14-MAF (1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5439713" y="3371631"/>
                  <a:ext cx="561051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15-WW11 (1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5862124" y="3329152"/>
                  <a:ext cx="476092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16-DO3 (1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6239668" y="3329152"/>
                  <a:ext cx="476092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17-STO (1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6363496" y="3329152"/>
                  <a:ext cx="476092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17-STO (2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5988333" y="3329152"/>
                  <a:ext cx="476092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16-DO3 (2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5570684" y="3371631"/>
                  <a:ext cx="561051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15-WW11 (2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5228457" y="3331556"/>
                  <a:ext cx="480901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14-MAF (2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4838064" y="3346785"/>
                  <a:ext cx="511358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13-WW7 (2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4480510" y="3331556"/>
                  <a:ext cx="480901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12-VOE (2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4108551" y="3328350"/>
                  <a:ext cx="474489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11-SAH (2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3705360" y="3353998"/>
                  <a:ext cx="525785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10-GNL1 (2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3114678" y="3313923"/>
                  <a:ext cx="445635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09-CHI (2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3240093" y="3313923"/>
                  <a:ext cx="445635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09-CHI (3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3365509" y="3313923"/>
                  <a:ext cx="445635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09-CHI (4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2713013" y="3345983"/>
                  <a:ext cx="509755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08-SA18 (2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2332284" y="3346784"/>
                  <a:ext cx="511358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07-WW5 (2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1954740" y="3346784"/>
                  <a:ext cx="511358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06-WW6 (2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1595630" y="3328350"/>
                  <a:ext cx="474489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05-BRE (2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9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1074631" y="3346784"/>
                  <a:ext cx="511358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914400"/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lang="de-DE" altLang="de-DE" sz="700" dirty="0">
                      <a:cs typeface="Arial" panose="020B0604020202020204" pitchFamily="34" charset="0"/>
                    </a:rPr>
                    <a:t>04-WW3 </a:t>
                  </a:r>
                  <a:r>
                    <a:rPr lang="de-DE" altLang="de-DE" sz="700" dirty="0" smtClean="0">
                      <a:cs typeface="Arial" panose="020B0604020202020204" pitchFamily="34" charset="0"/>
                    </a:rPr>
                    <a:t>(2)</a:t>
                  </a:r>
                  <a:endParaRPr lang="de-DE" altLang="de-DE" sz="700" dirty="0"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0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1199650" y="3346784"/>
                  <a:ext cx="511358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04-WW3 (3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1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716714" y="3328350"/>
                  <a:ext cx="474489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03-EBD (2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2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331133" y="3338769"/>
                  <a:ext cx="495328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02-SPW (2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</p:grpSp>
          <p:pic>
            <p:nvPicPr>
              <p:cNvPr id="43" name="Grafik 42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0662"/>
              <a:stretch/>
            </p:blipFill>
            <p:spPr>
              <a:xfrm>
                <a:off x="100012" y="4229320"/>
                <a:ext cx="6567485" cy="3243263"/>
              </a:xfrm>
              <a:prstGeom prst="rect">
                <a:avLst/>
              </a:prstGeom>
            </p:spPr>
          </p:pic>
          <p:grpSp>
            <p:nvGrpSpPr>
              <p:cNvPr id="85" name="Gruppieren 84"/>
              <p:cNvGrpSpPr/>
              <p:nvPr/>
            </p:nvGrpSpPr>
            <p:grpSpPr>
              <a:xfrm>
                <a:off x="145442" y="7479079"/>
                <a:ext cx="6386352" cy="678071"/>
                <a:chOff x="145442" y="7169296"/>
                <a:chExt cx="6386352" cy="678071"/>
              </a:xfrm>
            </p:grpSpPr>
            <p:sp>
              <p:nvSpPr>
                <p:cNvPr id="47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-51567" y="7366305"/>
                  <a:ext cx="501740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18-TOW (1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8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337180" y="7357489"/>
                  <a:ext cx="484107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19-NDN (1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9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691460" y="7383137"/>
                  <a:ext cx="535403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20-GNP5 (1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0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1227273" y="7351077"/>
                  <a:ext cx="471283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21-SOL (1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1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1555172" y="7395961"/>
                  <a:ext cx="561051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22-WW12 (1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2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2209977" y="7371114"/>
                  <a:ext cx="511358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lang="de-DE" altLang="de-DE" sz="700" dirty="0" smtClean="0">
                      <a:cs typeface="Arial" panose="020B0604020202020204" pitchFamily="34" charset="0"/>
                    </a:rPr>
                    <a:t>23-WW1 (1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3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2698524" y="7383938"/>
                  <a:ext cx="537006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24-WW2 </a:t>
                  </a:r>
                  <a:r>
                    <a:rPr kumimoji="0" lang="de-DE" altLang="de-DE" sz="700" u="none" strike="noStrike" cap="none" normalizeH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(1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4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3086512" y="7371114"/>
                  <a:ext cx="511358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25-WW9 (1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5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3432071" y="7395961"/>
                  <a:ext cx="561051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26-WW10 (1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6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3753486" y="7454471"/>
                  <a:ext cx="678071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27-CCY0002 (1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7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4232826" y="7352680"/>
                  <a:ext cx="474489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28-EDA</a:t>
                  </a:r>
                  <a:r>
                    <a:rPr kumimoji="0" lang="de-DE" altLang="de-DE" sz="700" u="none" strike="noStrike" cap="none" normalizeH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(1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9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5213127" y="7375122"/>
                  <a:ext cx="519373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lang="de-DE" altLang="de-DE" sz="700" dirty="0" smtClean="0">
                      <a:cs typeface="Arial" panose="020B0604020202020204" pitchFamily="34" charset="0"/>
                    </a:rPr>
                    <a:t>30-ASK5 (1)</a:t>
                  </a:r>
                  <a:endParaRPr kumimoji="0" lang="de-DE" altLang="de-DE" sz="700" u="none" strike="noStrike" cap="none" normalizeH="0" baseline="3000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0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5609907" y="7355886"/>
                  <a:ext cx="480901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31-LZW (1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1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6123274" y="7346268"/>
                  <a:ext cx="461665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32-WIS (1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2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77023" y="7366305"/>
                  <a:ext cx="501740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18-TOW (2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3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465771" y="7357489"/>
                  <a:ext cx="484107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19-NDN (2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4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817669" y="7383137"/>
                  <a:ext cx="535403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20-GNP5 (2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5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943878" y="7383137"/>
                  <a:ext cx="535403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20-GNP5 (3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6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1348718" y="7351077"/>
                  <a:ext cx="471283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21-SOL (2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7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1680584" y="7395961"/>
                  <a:ext cx="561051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22-WW12 (2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8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1805996" y="7395961"/>
                  <a:ext cx="561051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22-WW12 (3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9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1931409" y="7395961"/>
                  <a:ext cx="561051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22-WW12 (4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0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2334992" y="7371114"/>
                  <a:ext cx="511358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lang="de-DE" altLang="de-DE" sz="700" dirty="0" smtClean="0">
                      <a:cs typeface="Arial" panose="020B0604020202020204" pitchFamily="34" charset="0"/>
                    </a:rPr>
                    <a:t>23-WW1 (2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1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2460007" y="7371114"/>
                  <a:ext cx="511358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lang="de-DE" altLang="de-DE" sz="700" dirty="0" smtClean="0">
                      <a:cs typeface="Arial" panose="020B0604020202020204" pitchFamily="34" charset="0"/>
                    </a:rPr>
                    <a:t>23-WW1 (3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2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2837554" y="7371114"/>
                  <a:ext cx="511358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24-WW2 (2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3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3212720" y="7371114"/>
                  <a:ext cx="511358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25-WW9 (2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4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3560660" y="7395961"/>
                  <a:ext cx="561051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26-WW10 (2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5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3879695" y="7454471"/>
                  <a:ext cx="678071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27-CCY0002 (2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6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4358238" y="7352680"/>
                  <a:ext cx="474489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28-EDA (2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7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4483650" y="7352680"/>
                  <a:ext cx="474489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28-EDA (3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8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4609063" y="7352680"/>
                  <a:ext cx="474489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28-EDA (4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9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4961788" y="7375122"/>
                  <a:ext cx="519373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29-ASK1 (2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0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5339335" y="7375122"/>
                  <a:ext cx="519373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lang="de-DE" altLang="de-DE" sz="700" dirty="0" smtClean="0">
                      <a:cs typeface="Arial" panose="020B0604020202020204" pitchFamily="34" charset="0"/>
                    </a:rPr>
                    <a:t>30-ASK5 (2)</a:t>
                  </a:r>
                  <a:endParaRPr kumimoji="0" lang="de-DE" altLang="de-DE" sz="700" u="none" strike="noStrike" cap="none" normalizeH="0" baseline="3000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1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5737305" y="7355886"/>
                  <a:ext cx="480901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31-LZW (2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2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5864703" y="7355886"/>
                  <a:ext cx="480901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31-LZW (3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3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6247100" y="7346268"/>
                  <a:ext cx="461665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32-WIS (2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4" name="Rectangle 5">
                  <a:extLst>
                    <a:ext uri="{FF2B5EF4-FFF2-40B4-BE49-F238E27FC236}">
                      <a16:creationId xmlns:mc="http://schemas.openxmlformats.org/markup-compatibility/2006" xmlns:mv="urn:schemas-microsoft-com:mac:vml" xmlns:a16="http://schemas.microsoft.com/office/drawing/2014/main" xmlns="" id="{AEFC565E-B0E9-482E-AEC7-06DDBC651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4835584" y="7375122"/>
                  <a:ext cx="519373" cy="107722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700" u="none" strike="noStrike" cap="none" normalizeH="0" baseline="0" dirty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700" u="none" strike="noStrike" cap="none" normalizeH="0" baseline="0" dirty="0" smtClean="0">
                      <a:ln>
                        <a:noFill/>
                      </a:ln>
                      <a:effectLst/>
                      <a:cs typeface="Arial" panose="020B0604020202020204" pitchFamily="34" charset="0"/>
                    </a:rPr>
                    <a:t>29-ASK1 (1)</a:t>
                  </a:r>
                  <a:endParaRPr kumimoji="0" lang="de-DE" altLang="de-DE" sz="70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86" name="Gruppieren 85"/>
              <p:cNvGrpSpPr/>
              <p:nvPr/>
            </p:nvGrpSpPr>
            <p:grpSpPr>
              <a:xfrm>
                <a:off x="180978" y="8184970"/>
                <a:ext cx="6478161" cy="884140"/>
                <a:chOff x="342903" y="8980087"/>
                <a:chExt cx="6478161" cy="884140"/>
              </a:xfrm>
            </p:grpSpPr>
            <p:grpSp>
              <p:nvGrpSpPr>
                <p:cNvPr id="87" name="Gruppieren 86"/>
                <p:cNvGrpSpPr/>
                <p:nvPr/>
              </p:nvGrpSpPr>
              <p:grpSpPr>
                <a:xfrm>
                  <a:off x="342903" y="8980087"/>
                  <a:ext cx="6478161" cy="231111"/>
                  <a:chOff x="342903" y="9027712"/>
                  <a:chExt cx="6478161" cy="231111"/>
                </a:xfrm>
              </p:grpSpPr>
              <p:grpSp>
                <p:nvGrpSpPr>
                  <p:cNvPr id="127" name="Gruppieren 126"/>
                  <p:cNvGrpSpPr/>
                  <p:nvPr/>
                </p:nvGrpSpPr>
                <p:grpSpPr>
                  <a:xfrm>
                    <a:off x="342903" y="9027712"/>
                    <a:ext cx="1004768" cy="230832"/>
                    <a:chOff x="190500" y="9056289"/>
                    <a:chExt cx="1004768" cy="230832"/>
                  </a:xfrm>
                </p:grpSpPr>
                <p:sp>
                  <p:nvSpPr>
                    <p:cNvPr id="140" name="Textfeld 139">
                      <a:extLst>
                        <a:ext uri="{FF2B5EF4-FFF2-40B4-BE49-F238E27FC236}">
                          <a16:creationId xmlns="" xmlns:a16="http://schemas.microsoft.com/office/drawing/2014/main" id="{32EF4931-7221-464E-ACB0-FB53C49E7B3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39557" y="9056289"/>
                      <a:ext cx="955711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de-DE" sz="900" dirty="0" err="1" smtClean="0"/>
                        <a:t>Cyanobacteriota</a:t>
                      </a:r>
                      <a:endParaRPr lang="de-DE" sz="900" dirty="0"/>
                    </a:p>
                  </p:txBody>
                </p:sp>
                <p:sp>
                  <p:nvSpPr>
                    <p:cNvPr id="141" name="Rechteck 140"/>
                    <p:cNvSpPr/>
                    <p:nvPr/>
                  </p:nvSpPr>
                  <p:spPr>
                    <a:xfrm>
                      <a:off x="190500" y="9120188"/>
                      <a:ext cx="90000" cy="90000"/>
                    </a:xfrm>
                    <a:prstGeom prst="rect">
                      <a:avLst/>
                    </a:prstGeom>
                    <a:solidFill>
                      <a:srgbClr val="34DA00"/>
                    </a:solidFill>
                    <a:ln w="635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de-DE" sz="900"/>
                    </a:p>
                  </p:txBody>
                </p:sp>
              </p:grpSp>
              <p:grpSp>
                <p:nvGrpSpPr>
                  <p:cNvPr id="128" name="Gruppieren 127"/>
                  <p:cNvGrpSpPr/>
                  <p:nvPr/>
                </p:nvGrpSpPr>
                <p:grpSpPr>
                  <a:xfrm>
                    <a:off x="1638314" y="9027712"/>
                    <a:ext cx="838056" cy="230832"/>
                    <a:chOff x="190500" y="9056289"/>
                    <a:chExt cx="838056" cy="230832"/>
                  </a:xfrm>
                </p:grpSpPr>
                <p:sp>
                  <p:nvSpPr>
                    <p:cNvPr id="138" name="Textfeld 137">
                      <a:extLst>
                        <a:ext uri="{FF2B5EF4-FFF2-40B4-BE49-F238E27FC236}">
                          <a16:creationId xmlns="" xmlns:a16="http://schemas.microsoft.com/office/drawing/2014/main" id="{32EF4931-7221-464E-ACB0-FB53C49E7B3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39557" y="9056289"/>
                      <a:ext cx="788999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de-DE" sz="900" dirty="0" err="1" smtClean="0"/>
                        <a:t>Bacteroidota</a:t>
                      </a:r>
                      <a:endParaRPr lang="de-DE" sz="900" dirty="0"/>
                    </a:p>
                  </p:txBody>
                </p:sp>
                <p:sp>
                  <p:nvSpPr>
                    <p:cNvPr id="139" name="Rechteck 138"/>
                    <p:cNvSpPr/>
                    <p:nvPr/>
                  </p:nvSpPr>
                  <p:spPr>
                    <a:xfrm>
                      <a:off x="190500" y="9120188"/>
                      <a:ext cx="90000" cy="90000"/>
                    </a:xfrm>
                    <a:prstGeom prst="rect">
                      <a:avLst/>
                    </a:prstGeom>
                    <a:solidFill>
                      <a:srgbClr val="FFC000"/>
                    </a:solidFill>
                    <a:ln w="635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de-DE" sz="900"/>
                    </a:p>
                  </p:txBody>
                </p:sp>
              </p:grpSp>
              <p:grpSp>
                <p:nvGrpSpPr>
                  <p:cNvPr id="129" name="Gruppieren 128"/>
                  <p:cNvGrpSpPr/>
                  <p:nvPr/>
                </p:nvGrpSpPr>
                <p:grpSpPr>
                  <a:xfrm>
                    <a:off x="2928959" y="9027712"/>
                    <a:ext cx="1205143" cy="230832"/>
                    <a:chOff x="190500" y="9056289"/>
                    <a:chExt cx="1205143" cy="230832"/>
                  </a:xfrm>
                </p:grpSpPr>
                <p:sp>
                  <p:nvSpPr>
                    <p:cNvPr id="136" name="Textfeld 135">
                      <a:extLst>
                        <a:ext uri="{FF2B5EF4-FFF2-40B4-BE49-F238E27FC236}">
                          <a16:creationId xmlns="" xmlns:a16="http://schemas.microsoft.com/office/drawing/2014/main" id="{32EF4931-7221-464E-ACB0-FB53C49E7B3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39557" y="9056289"/>
                      <a:ext cx="1156086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de-DE" sz="900" dirty="0" err="1" smtClean="0"/>
                        <a:t>Alphaproteobacteria</a:t>
                      </a:r>
                      <a:endParaRPr lang="de-DE" sz="900" dirty="0"/>
                    </a:p>
                  </p:txBody>
                </p:sp>
                <p:sp>
                  <p:nvSpPr>
                    <p:cNvPr id="137" name="Rechteck 136"/>
                    <p:cNvSpPr/>
                    <p:nvPr/>
                  </p:nvSpPr>
                  <p:spPr>
                    <a:xfrm>
                      <a:off x="190500" y="9120188"/>
                      <a:ext cx="90000" cy="90000"/>
                    </a:xfrm>
                    <a:prstGeom prst="rect">
                      <a:avLst/>
                    </a:prstGeom>
                    <a:solidFill>
                      <a:srgbClr val="0000FF"/>
                    </a:solidFill>
                    <a:ln w="635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de-DE" sz="900"/>
                    </a:p>
                  </p:txBody>
                </p:sp>
              </p:grpSp>
              <p:grpSp>
                <p:nvGrpSpPr>
                  <p:cNvPr id="130" name="Gruppieren 129"/>
                  <p:cNvGrpSpPr/>
                  <p:nvPr/>
                </p:nvGrpSpPr>
                <p:grpSpPr>
                  <a:xfrm>
                    <a:off x="4224380" y="9027712"/>
                    <a:ext cx="1147435" cy="230832"/>
                    <a:chOff x="190500" y="9056289"/>
                    <a:chExt cx="1147435" cy="230832"/>
                  </a:xfrm>
                </p:grpSpPr>
                <p:sp>
                  <p:nvSpPr>
                    <p:cNvPr id="134" name="Textfeld 133">
                      <a:extLst>
                        <a:ext uri="{FF2B5EF4-FFF2-40B4-BE49-F238E27FC236}">
                          <a16:creationId xmlns="" xmlns:a16="http://schemas.microsoft.com/office/drawing/2014/main" id="{32EF4931-7221-464E-ACB0-FB53C49E7B3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39557" y="9056289"/>
                      <a:ext cx="1098378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de-DE" sz="900" dirty="0" err="1" smtClean="0"/>
                        <a:t>Betaproteobacteria</a:t>
                      </a:r>
                      <a:endParaRPr lang="de-DE" sz="900" dirty="0"/>
                    </a:p>
                  </p:txBody>
                </p:sp>
                <p:sp>
                  <p:nvSpPr>
                    <p:cNvPr id="135" name="Rechteck 134"/>
                    <p:cNvSpPr/>
                    <p:nvPr/>
                  </p:nvSpPr>
                  <p:spPr>
                    <a:xfrm>
                      <a:off x="190500" y="9120188"/>
                      <a:ext cx="90000" cy="90000"/>
                    </a:xfrm>
                    <a:prstGeom prst="rect">
                      <a:avLst/>
                    </a:prstGeom>
                    <a:solidFill>
                      <a:srgbClr val="0066FF"/>
                    </a:solidFill>
                    <a:ln w="635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de-DE" sz="900"/>
                    </a:p>
                  </p:txBody>
                </p:sp>
              </p:grpSp>
              <p:grpSp>
                <p:nvGrpSpPr>
                  <p:cNvPr id="131" name="Gruppieren 130"/>
                  <p:cNvGrpSpPr/>
                  <p:nvPr/>
                </p:nvGrpSpPr>
                <p:grpSpPr>
                  <a:xfrm>
                    <a:off x="5519741" y="9027991"/>
                    <a:ext cx="1301323" cy="230832"/>
                    <a:chOff x="190500" y="9056289"/>
                    <a:chExt cx="1301323" cy="230832"/>
                  </a:xfrm>
                </p:grpSpPr>
                <p:sp>
                  <p:nvSpPr>
                    <p:cNvPr id="132" name="Textfeld 131">
                      <a:extLst>
                        <a:ext uri="{FF2B5EF4-FFF2-40B4-BE49-F238E27FC236}">
                          <a16:creationId xmlns="" xmlns:a16="http://schemas.microsoft.com/office/drawing/2014/main" id="{32EF4931-7221-464E-ACB0-FB53C49E7B3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39557" y="9056289"/>
                      <a:ext cx="1252266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de-DE" sz="900" dirty="0" err="1" smtClean="0"/>
                        <a:t>Gammaproteobacteria</a:t>
                      </a:r>
                      <a:endParaRPr lang="de-DE" sz="900" dirty="0"/>
                    </a:p>
                  </p:txBody>
                </p:sp>
                <p:sp>
                  <p:nvSpPr>
                    <p:cNvPr id="133" name="Rechteck 132"/>
                    <p:cNvSpPr/>
                    <p:nvPr/>
                  </p:nvSpPr>
                  <p:spPr>
                    <a:xfrm>
                      <a:off x="190500" y="9120188"/>
                      <a:ext cx="90000" cy="90000"/>
                    </a:xfrm>
                    <a:prstGeom prst="rect">
                      <a:avLst/>
                    </a:prstGeom>
                    <a:solidFill>
                      <a:srgbClr val="3399FF"/>
                    </a:solidFill>
                    <a:ln w="635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de-DE" sz="900"/>
                    </a:p>
                  </p:txBody>
                </p:sp>
              </p:grpSp>
            </p:grpSp>
            <p:grpSp>
              <p:nvGrpSpPr>
                <p:cNvPr id="88" name="Gruppieren 87"/>
                <p:cNvGrpSpPr/>
                <p:nvPr/>
              </p:nvGrpSpPr>
              <p:grpSpPr>
                <a:xfrm>
                  <a:off x="342903" y="9633395"/>
                  <a:ext cx="1929885" cy="230832"/>
                  <a:chOff x="342903" y="9585770"/>
                  <a:chExt cx="1929885" cy="230832"/>
                </a:xfrm>
              </p:grpSpPr>
              <p:grpSp>
                <p:nvGrpSpPr>
                  <p:cNvPr id="121" name="Gruppieren 120"/>
                  <p:cNvGrpSpPr/>
                  <p:nvPr/>
                </p:nvGrpSpPr>
                <p:grpSpPr>
                  <a:xfrm>
                    <a:off x="342903" y="9585770"/>
                    <a:ext cx="833246" cy="230832"/>
                    <a:chOff x="190500" y="9056289"/>
                    <a:chExt cx="833246" cy="230832"/>
                  </a:xfrm>
                </p:grpSpPr>
                <p:sp>
                  <p:nvSpPr>
                    <p:cNvPr id="125" name="Textfeld 124">
                      <a:extLst>
                        <a:ext uri="{FF2B5EF4-FFF2-40B4-BE49-F238E27FC236}">
                          <a16:creationId xmlns="" xmlns:a16="http://schemas.microsoft.com/office/drawing/2014/main" id="{32EF4931-7221-464E-ACB0-FB53C49E7B3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39557" y="9056289"/>
                      <a:ext cx="784189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de-DE" sz="900" dirty="0" err="1" smtClean="0"/>
                        <a:t>Calditrichota</a:t>
                      </a:r>
                      <a:endParaRPr lang="de-DE" sz="900" dirty="0"/>
                    </a:p>
                  </p:txBody>
                </p:sp>
                <p:sp>
                  <p:nvSpPr>
                    <p:cNvPr id="126" name="Rechteck 125"/>
                    <p:cNvSpPr/>
                    <p:nvPr/>
                  </p:nvSpPr>
                  <p:spPr>
                    <a:xfrm>
                      <a:off x="190500" y="9120188"/>
                      <a:ext cx="90000" cy="90000"/>
                    </a:xfrm>
                    <a:prstGeom prst="rect">
                      <a:avLst/>
                    </a:prstGeom>
                    <a:solidFill>
                      <a:srgbClr val="009999"/>
                    </a:solidFill>
                    <a:ln w="635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de-DE" sz="900"/>
                    </a:p>
                  </p:txBody>
                </p:sp>
              </p:grpSp>
              <p:grpSp>
                <p:nvGrpSpPr>
                  <p:cNvPr id="122" name="Gruppieren 121"/>
                  <p:cNvGrpSpPr/>
                  <p:nvPr/>
                </p:nvGrpSpPr>
                <p:grpSpPr>
                  <a:xfrm>
                    <a:off x="1638314" y="9585770"/>
                    <a:ext cx="634474" cy="230832"/>
                    <a:chOff x="190500" y="9056289"/>
                    <a:chExt cx="634474" cy="230832"/>
                  </a:xfrm>
                </p:grpSpPr>
                <p:sp>
                  <p:nvSpPr>
                    <p:cNvPr id="123" name="Textfeld 122">
                      <a:extLst>
                        <a:ext uri="{FF2B5EF4-FFF2-40B4-BE49-F238E27FC236}">
                          <a16:creationId xmlns="" xmlns:a16="http://schemas.microsoft.com/office/drawing/2014/main" id="{32EF4931-7221-464E-ACB0-FB53C49E7B3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39557" y="9056289"/>
                      <a:ext cx="585417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de-DE" sz="900" dirty="0" err="1" smtClean="0"/>
                        <a:t>Bacillota</a:t>
                      </a:r>
                      <a:endParaRPr lang="de-DE" sz="900" dirty="0"/>
                    </a:p>
                  </p:txBody>
                </p:sp>
                <p:sp>
                  <p:nvSpPr>
                    <p:cNvPr id="124" name="Rechteck 123"/>
                    <p:cNvSpPr/>
                    <p:nvPr/>
                  </p:nvSpPr>
                  <p:spPr>
                    <a:xfrm>
                      <a:off x="190500" y="9120188"/>
                      <a:ext cx="90000" cy="90000"/>
                    </a:xfrm>
                    <a:prstGeom prst="rect">
                      <a:avLst/>
                    </a:prstGeom>
                    <a:solidFill>
                      <a:srgbClr val="FF9999"/>
                    </a:solidFill>
                    <a:ln w="635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de-DE" sz="900"/>
                    </a:p>
                  </p:txBody>
                </p:sp>
              </p:grpSp>
            </p:grpSp>
            <p:grpSp>
              <p:nvGrpSpPr>
                <p:cNvPr id="89" name="Gruppieren 88"/>
                <p:cNvGrpSpPr/>
                <p:nvPr/>
              </p:nvGrpSpPr>
              <p:grpSpPr>
                <a:xfrm>
                  <a:off x="342903" y="9198042"/>
                  <a:ext cx="6160766" cy="230832"/>
                  <a:chOff x="342903" y="9213731"/>
                  <a:chExt cx="6160766" cy="230832"/>
                </a:xfrm>
              </p:grpSpPr>
              <p:grpSp>
                <p:nvGrpSpPr>
                  <p:cNvPr id="106" name="Gruppieren 105"/>
                  <p:cNvGrpSpPr/>
                  <p:nvPr/>
                </p:nvGrpSpPr>
                <p:grpSpPr>
                  <a:xfrm>
                    <a:off x="342903" y="9213731"/>
                    <a:ext cx="1182701" cy="230832"/>
                    <a:chOff x="190500" y="9056289"/>
                    <a:chExt cx="1182701" cy="230832"/>
                  </a:xfrm>
                </p:grpSpPr>
                <p:sp>
                  <p:nvSpPr>
                    <p:cNvPr id="119" name="Textfeld 118">
                      <a:extLst>
                        <a:ext uri="{FF2B5EF4-FFF2-40B4-BE49-F238E27FC236}">
                          <a16:creationId xmlns="" xmlns:a16="http://schemas.microsoft.com/office/drawing/2014/main" id="{32EF4931-7221-464E-ACB0-FB53C49E7B3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39557" y="9056289"/>
                      <a:ext cx="1133644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de-DE" sz="900" dirty="0" err="1" smtClean="0"/>
                        <a:t>Deltaproteobacteria</a:t>
                      </a:r>
                      <a:endParaRPr lang="de-DE" sz="900" dirty="0"/>
                    </a:p>
                  </p:txBody>
                </p:sp>
                <p:sp>
                  <p:nvSpPr>
                    <p:cNvPr id="120" name="Rechteck 119"/>
                    <p:cNvSpPr/>
                    <p:nvPr/>
                  </p:nvSpPr>
                  <p:spPr>
                    <a:xfrm>
                      <a:off x="190500" y="9120188"/>
                      <a:ext cx="90000" cy="90000"/>
                    </a:xfrm>
                    <a:prstGeom prst="rect">
                      <a:avLst/>
                    </a:prstGeom>
                    <a:solidFill>
                      <a:srgbClr val="66CCFF"/>
                    </a:solidFill>
                    <a:ln w="635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de-DE" sz="900"/>
                    </a:p>
                  </p:txBody>
                </p:sp>
              </p:grpSp>
              <p:grpSp>
                <p:nvGrpSpPr>
                  <p:cNvPr id="107" name="Gruppieren 106"/>
                  <p:cNvGrpSpPr/>
                  <p:nvPr/>
                </p:nvGrpSpPr>
                <p:grpSpPr>
                  <a:xfrm>
                    <a:off x="1638314" y="9213731"/>
                    <a:ext cx="738669" cy="230832"/>
                    <a:chOff x="190500" y="9056289"/>
                    <a:chExt cx="738669" cy="230832"/>
                  </a:xfrm>
                </p:grpSpPr>
                <p:sp>
                  <p:nvSpPr>
                    <p:cNvPr id="117" name="Textfeld 116">
                      <a:extLst>
                        <a:ext uri="{FF2B5EF4-FFF2-40B4-BE49-F238E27FC236}">
                          <a16:creationId xmlns="" xmlns:a16="http://schemas.microsoft.com/office/drawing/2014/main" id="{32EF4931-7221-464E-ACB0-FB53C49E7B3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39557" y="9056289"/>
                      <a:ext cx="689612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de-DE" sz="900" dirty="0" err="1" smtClean="0"/>
                        <a:t>Balneolota</a:t>
                      </a:r>
                      <a:endParaRPr lang="de-DE" sz="900" dirty="0"/>
                    </a:p>
                  </p:txBody>
                </p:sp>
                <p:sp>
                  <p:nvSpPr>
                    <p:cNvPr id="118" name="Rechteck 117"/>
                    <p:cNvSpPr/>
                    <p:nvPr/>
                  </p:nvSpPr>
                  <p:spPr>
                    <a:xfrm>
                      <a:off x="190500" y="9120188"/>
                      <a:ext cx="90000" cy="90000"/>
                    </a:xfrm>
                    <a:prstGeom prst="rect">
                      <a:avLst/>
                    </a:prstGeom>
                    <a:solidFill>
                      <a:srgbClr val="FFFF00"/>
                    </a:solidFill>
                    <a:ln w="635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de-DE" sz="900"/>
                    </a:p>
                  </p:txBody>
                </p:sp>
              </p:grpSp>
              <p:grpSp>
                <p:nvGrpSpPr>
                  <p:cNvPr id="108" name="Gruppieren 107"/>
                  <p:cNvGrpSpPr/>
                  <p:nvPr/>
                </p:nvGrpSpPr>
                <p:grpSpPr>
                  <a:xfrm>
                    <a:off x="2928959" y="9213731"/>
                    <a:ext cx="980722" cy="230832"/>
                    <a:chOff x="190500" y="9056289"/>
                    <a:chExt cx="980722" cy="230832"/>
                  </a:xfrm>
                </p:grpSpPr>
                <p:sp>
                  <p:nvSpPr>
                    <p:cNvPr id="115" name="Textfeld 114">
                      <a:extLst>
                        <a:ext uri="{FF2B5EF4-FFF2-40B4-BE49-F238E27FC236}">
                          <a16:creationId xmlns="" xmlns:a16="http://schemas.microsoft.com/office/drawing/2014/main" id="{32EF4931-7221-464E-ACB0-FB53C49E7B3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39557" y="9056289"/>
                      <a:ext cx="931665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de-DE" sz="900" dirty="0" err="1" smtClean="0"/>
                        <a:t>Actinomycetota</a:t>
                      </a:r>
                      <a:endParaRPr lang="de-DE" sz="900" dirty="0"/>
                    </a:p>
                  </p:txBody>
                </p:sp>
                <p:sp>
                  <p:nvSpPr>
                    <p:cNvPr id="116" name="Rechteck 115"/>
                    <p:cNvSpPr/>
                    <p:nvPr/>
                  </p:nvSpPr>
                  <p:spPr>
                    <a:xfrm>
                      <a:off x="190500" y="9120188"/>
                      <a:ext cx="90000" cy="90000"/>
                    </a:xfrm>
                    <a:prstGeom prst="rect">
                      <a:avLst/>
                    </a:prstGeom>
                    <a:solidFill>
                      <a:srgbClr val="833C0C"/>
                    </a:solidFill>
                    <a:ln w="635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de-DE" sz="900"/>
                    </a:p>
                  </p:txBody>
                </p:sp>
              </p:grpSp>
              <p:grpSp>
                <p:nvGrpSpPr>
                  <p:cNvPr id="109" name="Gruppieren 108"/>
                  <p:cNvGrpSpPr/>
                  <p:nvPr/>
                </p:nvGrpSpPr>
                <p:grpSpPr>
                  <a:xfrm>
                    <a:off x="4224380" y="9213731"/>
                    <a:ext cx="889352" cy="230832"/>
                    <a:chOff x="190500" y="9056289"/>
                    <a:chExt cx="889352" cy="230832"/>
                  </a:xfrm>
                </p:grpSpPr>
                <p:sp>
                  <p:nvSpPr>
                    <p:cNvPr id="113" name="Textfeld 112">
                      <a:extLst>
                        <a:ext uri="{FF2B5EF4-FFF2-40B4-BE49-F238E27FC236}">
                          <a16:creationId xmlns="" xmlns:a16="http://schemas.microsoft.com/office/drawing/2014/main" id="{32EF4931-7221-464E-ACB0-FB53C49E7B3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39557" y="9056289"/>
                      <a:ext cx="840295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de-DE" sz="900" dirty="0" err="1" smtClean="0"/>
                        <a:t>Spirochaetota</a:t>
                      </a:r>
                      <a:endParaRPr lang="de-DE" sz="900" dirty="0"/>
                    </a:p>
                  </p:txBody>
                </p:sp>
                <p:sp>
                  <p:nvSpPr>
                    <p:cNvPr id="114" name="Rechteck 113"/>
                    <p:cNvSpPr/>
                    <p:nvPr/>
                  </p:nvSpPr>
                  <p:spPr>
                    <a:xfrm>
                      <a:off x="190500" y="9120188"/>
                      <a:ext cx="90000" cy="90000"/>
                    </a:xfrm>
                    <a:prstGeom prst="rect">
                      <a:avLst/>
                    </a:prstGeom>
                    <a:solidFill>
                      <a:srgbClr val="00FFFF"/>
                    </a:solidFill>
                    <a:ln w="635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de-DE" sz="900"/>
                    </a:p>
                  </p:txBody>
                </p:sp>
              </p:grpSp>
              <p:grpSp>
                <p:nvGrpSpPr>
                  <p:cNvPr id="110" name="Gruppieren 109"/>
                  <p:cNvGrpSpPr/>
                  <p:nvPr/>
                </p:nvGrpSpPr>
                <p:grpSpPr>
                  <a:xfrm>
                    <a:off x="5519741" y="9213731"/>
                    <a:ext cx="983928" cy="230832"/>
                    <a:chOff x="190500" y="9056289"/>
                    <a:chExt cx="983928" cy="230832"/>
                  </a:xfrm>
                </p:grpSpPr>
                <p:sp>
                  <p:nvSpPr>
                    <p:cNvPr id="111" name="Textfeld 110">
                      <a:extLst>
                        <a:ext uri="{FF2B5EF4-FFF2-40B4-BE49-F238E27FC236}">
                          <a16:creationId xmlns="" xmlns:a16="http://schemas.microsoft.com/office/drawing/2014/main" id="{32EF4931-7221-464E-ACB0-FB53C49E7B3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39557" y="9056289"/>
                      <a:ext cx="934871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de-DE" sz="900" dirty="0" err="1" smtClean="0"/>
                        <a:t>Rhodothermota</a:t>
                      </a:r>
                      <a:endParaRPr lang="de-DE" sz="900" dirty="0"/>
                    </a:p>
                  </p:txBody>
                </p:sp>
                <p:sp>
                  <p:nvSpPr>
                    <p:cNvPr id="112" name="Rechteck 111"/>
                    <p:cNvSpPr/>
                    <p:nvPr/>
                  </p:nvSpPr>
                  <p:spPr>
                    <a:xfrm>
                      <a:off x="190500" y="9120188"/>
                      <a:ext cx="90000" cy="90000"/>
                    </a:xfrm>
                    <a:prstGeom prst="rect">
                      <a:avLst/>
                    </a:prstGeom>
                    <a:solidFill>
                      <a:srgbClr val="7F7F7F"/>
                    </a:solidFill>
                    <a:ln w="635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de-DE" sz="900"/>
                    </a:p>
                  </p:txBody>
                </p:sp>
              </p:grpSp>
            </p:grpSp>
            <p:grpSp>
              <p:nvGrpSpPr>
                <p:cNvPr id="90" name="Gruppieren 89"/>
                <p:cNvGrpSpPr/>
                <p:nvPr/>
              </p:nvGrpSpPr>
              <p:grpSpPr>
                <a:xfrm>
                  <a:off x="342903" y="9415718"/>
                  <a:ext cx="5963597" cy="230832"/>
                  <a:chOff x="342903" y="9399750"/>
                  <a:chExt cx="5963597" cy="230832"/>
                </a:xfrm>
              </p:grpSpPr>
              <p:grpSp>
                <p:nvGrpSpPr>
                  <p:cNvPr id="91" name="Gruppieren 90"/>
                  <p:cNvGrpSpPr/>
                  <p:nvPr/>
                </p:nvGrpSpPr>
                <p:grpSpPr>
                  <a:xfrm>
                    <a:off x="342903" y="9399750"/>
                    <a:ext cx="1153847" cy="230832"/>
                    <a:chOff x="190500" y="9056289"/>
                    <a:chExt cx="1153847" cy="230832"/>
                  </a:xfrm>
                </p:grpSpPr>
                <p:sp>
                  <p:nvSpPr>
                    <p:cNvPr id="104" name="Textfeld 103">
                      <a:extLst>
                        <a:ext uri="{FF2B5EF4-FFF2-40B4-BE49-F238E27FC236}">
                          <a16:creationId xmlns="" xmlns:a16="http://schemas.microsoft.com/office/drawing/2014/main" id="{32EF4931-7221-464E-ACB0-FB53C49E7B3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39557" y="9056289"/>
                      <a:ext cx="1104790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de-DE" sz="900" dirty="0" err="1" smtClean="0"/>
                        <a:t>Gemmatimonadota</a:t>
                      </a:r>
                      <a:endParaRPr lang="de-DE" sz="900" dirty="0"/>
                    </a:p>
                  </p:txBody>
                </p:sp>
                <p:sp>
                  <p:nvSpPr>
                    <p:cNvPr id="105" name="Rechteck 104"/>
                    <p:cNvSpPr/>
                    <p:nvPr/>
                  </p:nvSpPr>
                  <p:spPr>
                    <a:xfrm>
                      <a:off x="190500" y="9120188"/>
                      <a:ext cx="90000" cy="90000"/>
                    </a:xfrm>
                    <a:prstGeom prst="rect">
                      <a:avLst/>
                    </a:prstGeom>
                    <a:solidFill>
                      <a:srgbClr val="7030A0"/>
                    </a:solidFill>
                    <a:ln w="635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de-DE" sz="900"/>
                    </a:p>
                  </p:txBody>
                </p:sp>
              </p:grpSp>
              <p:grpSp>
                <p:nvGrpSpPr>
                  <p:cNvPr id="92" name="Gruppieren 91"/>
                  <p:cNvGrpSpPr/>
                  <p:nvPr/>
                </p:nvGrpSpPr>
                <p:grpSpPr>
                  <a:xfrm>
                    <a:off x="2928959" y="9399750"/>
                    <a:ext cx="868512" cy="230832"/>
                    <a:chOff x="190500" y="9056289"/>
                    <a:chExt cx="868512" cy="230832"/>
                  </a:xfrm>
                </p:grpSpPr>
                <p:sp>
                  <p:nvSpPr>
                    <p:cNvPr id="102" name="Textfeld 101">
                      <a:extLst>
                        <a:ext uri="{FF2B5EF4-FFF2-40B4-BE49-F238E27FC236}">
                          <a16:creationId xmlns="" xmlns:a16="http://schemas.microsoft.com/office/drawing/2014/main" id="{32EF4931-7221-464E-ACB0-FB53C49E7B3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39557" y="9056289"/>
                      <a:ext cx="819455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de-DE" sz="900" dirty="0" err="1" smtClean="0"/>
                        <a:t>Chloroflexota</a:t>
                      </a:r>
                      <a:endParaRPr lang="de-DE" sz="900" dirty="0"/>
                    </a:p>
                  </p:txBody>
                </p:sp>
                <p:sp>
                  <p:nvSpPr>
                    <p:cNvPr id="103" name="Rechteck 102"/>
                    <p:cNvSpPr/>
                    <p:nvPr/>
                  </p:nvSpPr>
                  <p:spPr>
                    <a:xfrm>
                      <a:off x="190500" y="9120188"/>
                      <a:ext cx="90000" cy="90000"/>
                    </a:xfrm>
                    <a:prstGeom prst="rect">
                      <a:avLst/>
                    </a:prstGeom>
                    <a:solidFill>
                      <a:srgbClr val="CCFF33"/>
                    </a:solidFill>
                    <a:ln w="635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de-DE" sz="900"/>
                    </a:p>
                  </p:txBody>
                </p:sp>
              </p:grpSp>
              <p:grpSp>
                <p:nvGrpSpPr>
                  <p:cNvPr id="93" name="Gruppieren 92"/>
                  <p:cNvGrpSpPr/>
                  <p:nvPr/>
                </p:nvGrpSpPr>
                <p:grpSpPr>
                  <a:xfrm>
                    <a:off x="1638314" y="9399750"/>
                    <a:ext cx="1118581" cy="230832"/>
                    <a:chOff x="190500" y="9056289"/>
                    <a:chExt cx="1118581" cy="230832"/>
                  </a:xfrm>
                </p:grpSpPr>
                <p:sp>
                  <p:nvSpPr>
                    <p:cNvPr id="100" name="Textfeld 99">
                      <a:extLst>
                        <a:ext uri="{FF2B5EF4-FFF2-40B4-BE49-F238E27FC236}">
                          <a16:creationId xmlns="" xmlns:a16="http://schemas.microsoft.com/office/drawing/2014/main" id="{32EF4931-7221-464E-ACB0-FB53C49E7B3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39557" y="9056289"/>
                      <a:ext cx="1069524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de-DE" sz="900" dirty="0" err="1" smtClean="0"/>
                        <a:t>Verrucomicrobiota</a:t>
                      </a:r>
                      <a:endParaRPr lang="de-DE" sz="900" dirty="0"/>
                    </a:p>
                  </p:txBody>
                </p:sp>
                <p:sp>
                  <p:nvSpPr>
                    <p:cNvPr id="101" name="Rechteck 100"/>
                    <p:cNvSpPr/>
                    <p:nvPr/>
                  </p:nvSpPr>
                  <p:spPr>
                    <a:xfrm>
                      <a:off x="190500" y="9120188"/>
                      <a:ext cx="90000" cy="90000"/>
                    </a:xfrm>
                    <a:prstGeom prst="rect">
                      <a:avLst/>
                    </a:prstGeom>
                    <a:solidFill>
                      <a:srgbClr val="990099"/>
                    </a:solidFill>
                    <a:ln w="635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de-DE" sz="900"/>
                    </a:p>
                  </p:txBody>
                </p:sp>
              </p:grpSp>
              <p:grpSp>
                <p:nvGrpSpPr>
                  <p:cNvPr id="94" name="Gruppieren 93"/>
                  <p:cNvGrpSpPr/>
                  <p:nvPr/>
                </p:nvGrpSpPr>
                <p:grpSpPr>
                  <a:xfrm>
                    <a:off x="5519741" y="9399750"/>
                    <a:ext cx="786759" cy="230832"/>
                    <a:chOff x="190500" y="9056289"/>
                    <a:chExt cx="786759" cy="230832"/>
                  </a:xfrm>
                </p:grpSpPr>
                <p:sp>
                  <p:nvSpPr>
                    <p:cNvPr id="98" name="Textfeld 97">
                      <a:extLst>
                        <a:ext uri="{FF2B5EF4-FFF2-40B4-BE49-F238E27FC236}">
                          <a16:creationId xmlns="" xmlns:a16="http://schemas.microsoft.com/office/drawing/2014/main" id="{32EF4931-7221-464E-ACB0-FB53C49E7B3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39557" y="9056289"/>
                      <a:ext cx="737702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de-DE" sz="900" dirty="0" err="1" smtClean="0"/>
                        <a:t>Chlorobiota</a:t>
                      </a:r>
                      <a:endParaRPr lang="de-DE" sz="900" dirty="0"/>
                    </a:p>
                  </p:txBody>
                </p:sp>
                <p:sp>
                  <p:nvSpPr>
                    <p:cNvPr id="99" name="Rechteck 98"/>
                    <p:cNvSpPr/>
                    <p:nvPr/>
                  </p:nvSpPr>
                  <p:spPr>
                    <a:xfrm>
                      <a:off x="190500" y="9120188"/>
                      <a:ext cx="90000" cy="90000"/>
                    </a:xfrm>
                    <a:prstGeom prst="rect">
                      <a:avLst/>
                    </a:prstGeom>
                    <a:solidFill>
                      <a:srgbClr val="808000"/>
                    </a:solidFill>
                    <a:ln w="635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de-DE" sz="900"/>
                    </a:p>
                  </p:txBody>
                </p:sp>
              </p:grpSp>
              <p:grpSp>
                <p:nvGrpSpPr>
                  <p:cNvPr id="95" name="Gruppieren 94"/>
                  <p:cNvGrpSpPr/>
                  <p:nvPr/>
                </p:nvGrpSpPr>
                <p:grpSpPr>
                  <a:xfrm>
                    <a:off x="4224380" y="9399750"/>
                    <a:ext cx="979120" cy="230832"/>
                    <a:chOff x="190500" y="9056289"/>
                    <a:chExt cx="979120" cy="230832"/>
                  </a:xfrm>
                </p:grpSpPr>
                <p:sp>
                  <p:nvSpPr>
                    <p:cNvPr id="96" name="Textfeld 95">
                      <a:extLst>
                        <a:ext uri="{FF2B5EF4-FFF2-40B4-BE49-F238E27FC236}">
                          <a16:creationId xmlns="" xmlns:a16="http://schemas.microsoft.com/office/drawing/2014/main" id="{32EF4931-7221-464E-ACB0-FB53C49E7B3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39557" y="9056289"/>
                      <a:ext cx="930063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de-DE" sz="900" dirty="0" err="1" smtClean="0"/>
                        <a:t>Acidobacteriota</a:t>
                      </a:r>
                      <a:endParaRPr lang="de-DE" sz="900" dirty="0"/>
                    </a:p>
                  </p:txBody>
                </p:sp>
                <p:sp>
                  <p:nvSpPr>
                    <p:cNvPr id="97" name="Rechteck 96"/>
                    <p:cNvSpPr/>
                    <p:nvPr/>
                  </p:nvSpPr>
                  <p:spPr>
                    <a:xfrm>
                      <a:off x="190500" y="9120188"/>
                      <a:ext cx="90000" cy="90000"/>
                    </a:xfrm>
                    <a:prstGeom prst="rect">
                      <a:avLst/>
                    </a:prstGeom>
                    <a:solidFill>
                      <a:srgbClr val="A30021"/>
                    </a:solidFill>
                    <a:ln w="635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de-DE" sz="900"/>
                    </a:p>
                  </p:txBody>
                </p:sp>
              </p:grpSp>
            </p:grpSp>
          </p:grpSp>
        </p:grpSp>
        <p:sp>
          <p:nvSpPr>
            <p:cNvPr id="142" name="Textfeld 141"/>
            <p:cNvSpPr txBox="1"/>
            <p:nvPr/>
          </p:nvSpPr>
          <p:spPr>
            <a:xfrm>
              <a:off x="0" y="9258300"/>
              <a:ext cx="685800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de-DE" sz="1200" b="1" dirty="0" err="1" smtClean="0"/>
                <a:t>Figure</a:t>
              </a:r>
              <a:r>
                <a:rPr lang="de-DE" sz="1200" b="1" smtClean="0"/>
                <a:t> </a:t>
              </a:r>
              <a:r>
                <a:rPr lang="de-DE" sz="1200" b="1" smtClean="0"/>
                <a:t>S1</a:t>
              </a:r>
              <a:r>
                <a:rPr lang="de-DE" sz="1200" smtClean="0"/>
                <a:t>. </a:t>
              </a:r>
              <a:r>
                <a:rPr lang="de-DE" sz="1200" dirty="0" err="1" smtClean="0"/>
                <a:t>Bacterial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composition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of</a:t>
              </a:r>
              <a:r>
                <a:rPr lang="de-DE" sz="1200" dirty="0" smtClean="0"/>
                <a:t> 32 non-</a:t>
              </a:r>
              <a:r>
                <a:rPr lang="de-DE" sz="1200" dirty="0" err="1" smtClean="0"/>
                <a:t>axenic</a:t>
              </a:r>
              <a:r>
                <a:rPr lang="de-DE" sz="1200" dirty="0" smtClean="0"/>
                <a:t> </a:t>
              </a:r>
              <a:r>
                <a:rPr lang="de-DE" sz="1200" i="1" dirty="0" err="1" smtClean="0"/>
                <a:t>Coleofasciculus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strains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based</a:t>
              </a:r>
              <a:r>
                <a:rPr lang="de-DE" sz="1200" dirty="0" smtClean="0"/>
                <a:t> on 16S-ITS </a:t>
              </a:r>
              <a:r>
                <a:rPr lang="de-DE" sz="1200" dirty="0" err="1" smtClean="0"/>
                <a:t>amplicon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sequencing</a:t>
              </a:r>
              <a:r>
                <a:rPr lang="de-DE" sz="1200" dirty="0" smtClean="0"/>
                <a:t>. The bar </a:t>
              </a:r>
              <a:r>
                <a:rPr lang="de-DE" sz="1200" dirty="0" err="1" smtClean="0"/>
                <a:t>graph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shows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the</a:t>
              </a:r>
              <a:r>
                <a:rPr lang="de-DE" sz="1200" dirty="0" smtClean="0"/>
                <a:t> ASVs </a:t>
              </a:r>
              <a:r>
                <a:rPr lang="de-DE" sz="1200" dirty="0" err="1" smtClean="0"/>
                <a:t>from</a:t>
              </a:r>
              <a:r>
                <a:rPr lang="de-DE" sz="1200" dirty="0" smtClean="0"/>
                <a:t> all </a:t>
              </a:r>
              <a:r>
                <a:rPr lang="de-DE" sz="1200" dirty="0" err="1" smtClean="0"/>
                <a:t>sequencing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runs</a:t>
              </a:r>
              <a:r>
                <a:rPr lang="de-DE" sz="1200" dirty="0" smtClean="0"/>
                <a:t> (Table S1). ASVs, </a:t>
              </a:r>
              <a:r>
                <a:rPr lang="de-DE" sz="1200" dirty="0" err="1" smtClean="0"/>
                <a:t>amplicon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sequence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variants</a:t>
              </a:r>
              <a:r>
                <a:rPr lang="de-DE" sz="1200" dirty="0" smtClean="0"/>
                <a:t>.</a:t>
              </a:r>
              <a:endParaRPr lang="de-DE" sz="1200" dirty="0"/>
            </a:p>
          </p:txBody>
        </p:sp>
        <p:sp>
          <p:nvSpPr>
            <p:cNvPr id="143" name="Rectangle 5">
              <a:extLst>
                <a:ext uri="{FF2B5EF4-FFF2-40B4-BE49-F238E27FC236}">
                  <a16:creationId xmlns="" xmlns:a16="http://schemas.microsoft.com/office/drawing/2014/main" xmlns:mv="urn:schemas-microsoft-com:mac:vml" xmlns:mc="http://schemas.openxmlformats.org/markup-compatibility/2006" id="{AEFC565E-B0E9-482E-AEC7-06DDBC651E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56094" y="72671"/>
              <a:ext cx="583878" cy="246221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600" b="1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rPr>
                <a:t> </a:t>
              </a:r>
              <a:r>
                <a:rPr kumimoji="0" lang="de-DE" altLang="de-DE" sz="1600" b="1" u="none" strike="noStrike" cap="none" normalizeH="0" baseline="0" dirty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ASVs</a:t>
              </a:r>
              <a:endParaRPr kumimoji="0" lang="de-DE" altLang="de-DE" sz="1600" b="1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1811391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17</Words>
  <Application>Microsoft Office PowerPoint</Application>
  <PresentationFormat>A4-Papier (210x297 mm)</PresentationFormat>
  <Paragraphs>92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Pia Marter</dc:creator>
  <cp:lastModifiedBy>Petersen, Joern</cp:lastModifiedBy>
  <cp:revision>27</cp:revision>
  <cp:lastPrinted>2023-07-10T09:24:27Z</cp:lastPrinted>
  <dcterms:created xsi:type="dcterms:W3CDTF">2023-07-03T12:02:12Z</dcterms:created>
  <dcterms:modified xsi:type="dcterms:W3CDTF">2023-12-13T11:59:34Z</dcterms:modified>
</cp:coreProperties>
</file>